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2" autoAdjust="0"/>
    <p:restoredTop sz="94660"/>
  </p:normalViewPr>
  <p:slideViewPr>
    <p:cSldViewPr snapToGrid="0" showGuides="1">
      <p:cViewPr varScale="1">
        <p:scale>
          <a:sx n="97" d="100"/>
          <a:sy n="97" d="100"/>
        </p:scale>
        <p:origin x="78" y="2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Feuil1!$O$3:$O$8</c:f>
                <c:numCache>
                  <c:formatCode>General</c:formatCode>
                  <c:ptCount val="6"/>
                  <c:pt idx="0">
                    <c:v>56.473557234102046</c:v>
                  </c:pt>
                  <c:pt idx="1">
                    <c:v>38.980192352277463</c:v>
                  </c:pt>
                  <c:pt idx="2">
                    <c:v>89.895472913973393</c:v>
                  </c:pt>
                  <c:pt idx="3">
                    <c:v>27.063180976116275</c:v>
                  </c:pt>
                  <c:pt idx="4">
                    <c:v>28.01771363428962</c:v>
                  </c:pt>
                  <c:pt idx="5">
                    <c:v>31.070696533463742</c:v>
                  </c:pt>
                </c:numCache>
              </c:numRef>
            </c:plus>
            <c:minus>
              <c:numRef>
                <c:f>Feuil1!$O$3:$O$8</c:f>
                <c:numCache>
                  <c:formatCode>General</c:formatCode>
                  <c:ptCount val="6"/>
                  <c:pt idx="0">
                    <c:v>56.473557234102046</c:v>
                  </c:pt>
                  <c:pt idx="1">
                    <c:v>38.980192352277463</c:v>
                  </c:pt>
                  <c:pt idx="2">
                    <c:v>89.895472913973393</c:v>
                  </c:pt>
                  <c:pt idx="3">
                    <c:v>27.063180976116275</c:v>
                  </c:pt>
                  <c:pt idx="4">
                    <c:v>28.01771363428962</c:v>
                  </c:pt>
                  <c:pt idx="5">
                    <c:v>31.070696533463742</c:v>
                  </c:pt>
                </c:numCache>
              </c:numRef>
            </c:minus>
          </c:errBars>
          <c:cat>
            <c:strRef>
              <c:f>Feuil1!$M$2:$M$8</c:f>
              <c:strCache>
                <c:ptCount val="7"/>
                <c:pt idx="0">
                  <c:v>Buffer </c:v>
                </c:pt>
                <c:pt idx="1">
                  <c:v>A17 extract ice</c:v>
                </c:pt>
                <c:pt idx="2">
                  <c:v>A17 extract 37°C 15 min</c:v>
                </c:pt>
                <c:pt idx="3">
                  <c:v>A17 extract 37°C 15 min + RNAse A</c:v>
                </c:pt>
                <c:pt idx="4">
                  <c:v>NFYA extract ice</c:v>
                </c:pt>
                <c:pt idx="5">
                  <c:v>NFYA extract 37°C 15 min</c:v>
                </c:pt>
                <c:pt idx="6">
                  <c:v>NFYA extract 37°C 15 min + RNAse A</c:v>
                </c:pt>
              </c:strCache>
            </c:strRef>
          </c:cat>
          <c:val>
            <c:numRef>
              <c:f>Feuil1!$N$2:$N$8</c:f>
              <c:numCache>
                <c:formatCode>General</c:formatCode>
                <c:ptCount val="7"/>
                <c:pt idx="0">
                  <c:v>284.60000000000002</c:v>
                </c:pt>
                <c:pt idx="1">
                  <c:v>2029.1099048221222</c:v>
                </c:pt>
                <c:pt idx="2">
                  <c:v>1703.8716136182481</c:v>
                </c:pt>
                <c:pt idx="3">
                  <c:v>1783.5329784087546</c:v>
                </c:pt>
                <c:pt idx="4">
                  <c:v>426.61788044436611</c:v>
                </c:pt>
                <c:pt idx="5">
                  <c:v>464.28571428571428</c:v>
                </c:pt>
                <c:pt idx="6">
                  <c:v>515.963761324586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1D-4CEE-BF99-244422672A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2112384"/>
        <c:axId val="52122368"/>
      </c:barChart>
      <c:catAx>
        <c:axId val="521123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52122368"/>
        <c:crosses val="autoZero"/>
        <c:auto val="1"/>
        <c:lblAlgn val="ctr"/>
        <c:lblOffset val="100"/>
        <c:noMultiLvlLbl val="0"/>
      </c:catAx>
      <c:valAx>
        <c:axId val="5212236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521123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Feuil1!$K$27,Feuil1!$K$29)</c:f>
              <c:strCache>
                <c:ptCount val="2"/>
                <c:pt idx="0">
                  <c:v>Nodule extract </c:v>
                </c:pt>
                <c:pt idx="1">
                  <c:v>Nodule extract + RNasin</c:v>
                </c:pt>
              </c:strCache>
            </c:strRef>
          </c:cat>
          <c:val>
            <c:numRef>
              <c:f>(Feuil1!$O$27,Feuil1!$O$29)</c:f>
              <c:numCache>
                <c:formatCode>General</c:formatCode>
                <c:ptCount val="2"/>
                <c:pt idx="0">
                  <c:v>2674.5121490817892</c:v>
                </c:pt>
                <c:pt idx="1">
                  <c:v>2164.64626990942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98-44BA-88FD-C515EA66E0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310223"/>
        <c:axId val="194315631"/>
      </c:barChart>
      <c:catAx>
        <c:axId val="1943102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94315631"/>
        <c:crosses val="autoZero"/>
        <c:auto val="1"/>
        <c:lblAlgn val="ctr"/>
        <c:lblOffset val="100"/>
        <c:noMultiLvlLbl val="0"/>
      </c:catAx>
      <c:valAx>
        <c:axId val="19431563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943102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7099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120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8950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0999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5430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6150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3366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2566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7530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1710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7852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205C7-D2D2-43A8-B693-D13AE3A21B3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9AC40-00CD-4B1B-9133-0685FBE94D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1870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629126" y="1137684"/>
          <a:ext cx="3126356" cy="44578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3025612" y="6169269"/>
            <a:ext cx="69764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 Fig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se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se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hibitors treatments do not impact nodule extracts signaling activity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 rot="16200000">
            <a:off x="1591816" y="2100665"/>
            <a:ext cx="1861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fr-FR" sz="12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Miller </a:t>
            </a:r>
            <a:r>
              <a:rPr lang="fr-FR" sz="120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units</a:t>
            </a:r>
            <a:endParaRPr lang="en-US" sz="120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 rot="16200000">
            <a:off x="5440818" y="2100665"/>
            <a:ext cx="1869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fr-FR" sz="12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Miller </a:t>
            </a:r>
            <a:r>
              <a:rPr lang="fr-FR" sz="1200" dirty="0" err="1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units</a:t>
            </a:r>
            <a:endParaRPr lang="en-US" sz="120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8" name="Graphique 7"/>
          <p:cNvGraphicFramePr>
            <a:graphicFrameLocks/>
          </p:cNvGraphicFramePr>
          <p:nvPr>
            <p:extLst/>
          </p:nvPr>
        </p:nvGraphicFramePr>
        <p:xfrm>
          <a:off x="6513844" y="1137684"/>
          <a:ext cx="291332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ZoneTexte 8"/>
          <p:cNvSpPr txBox="1"/>
          <p:nvPr/>
        </p:nvSpPr>
        <p:spPr>
          <a:xfrm>
            <a:off x="2384297" y="85158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6236844" y="85158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8573386" y="162551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2754380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Grand écran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batut</dc:creator>
  <cp:lastModifiedBy>jbatut</cp:lastModifiedBy>
  <cp:revision>1</cp:revision>
  <dcterms:created xsi:type="dcterms:W3CDTF">2020-02-27T11:38:45Z</dcterms:created>
  <dcterms:modified xsi:type="dcterms:W3CDTF">2020-02-27T11:39:04Z</dcterms:modified>
</cp:coreProperties>
</file>